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7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3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B521BF-5640-4390-99C6-BB27C08673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5E9B78B-E62B-41D5-B4B9-088EC260CA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85A565F-B2BE-4034-BAA2-79C6A25E1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2F9708-5513-4D33-B893-D915BD30C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78B04B7-B7C3-4CE8-8EEC-3E9BB1870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3154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152891-3430-43A4-BB70-839B61C7E0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D3D6D3A-D559-475D-B099-12DAE6DE65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E98302-C08D-4F39-87C8-27176C6C5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9BA887-D7A8-4572-8EA3-F727733A2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2CE396F-D32C-449A-AD1B-4E22C40AD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1993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2DBBEFF-E047-482C-B332-77748A814E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1A5C6DE-8822-47D9-A3DE-95E6861B9B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4F1324-5214-4EC7-9AAE-11E15D7B3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69674C-F3CF-416D-9A09-95182D3FA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A5E30D-47B3-43FC-B774-FB7D97DB4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167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EC4EBB-B995-49EC-9B7A-05BC73516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DC2FE53-64E2-443C-9F7F-12CB8EC1FC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E1906D0-DFAA-4DCA-ACDD-842833D3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EE5040E-8E27-415D-A2B4-F4BA5C9FD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7C0A16-9DD6-495B-B0FD-606A31724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0700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F1108D1-E8D1-49C2-A11C-75B97B6BC4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F26D37D-8500-4FD3-8772-C73B4E0F3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BC01EC1-1AB6-4C7A-BF55-C579974AE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2BCDFAF-B5B3-4455-8B7E-CB4BB219A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4E0FC0-1A5C-4083-B5D1-5AC28DA93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1931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61E59E-68B4-47FE-A0F3-9A61B5A4AC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AF861EC-B76F-46C7-9ED5-FED33C732F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F7D2696-063E-464C-BC4B-5CBF7126EA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39867D5-1538-44D6-89A7-BC1C30E85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48FD32-7B83-4F98-851E-0961C0CCC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4434BCD-84CB-4EAB-AFDE-046E2442E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832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421B58-474F-4D5B-9EC5-FBB569214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EA5B3BA-2BE5-40B8-B443-26CC4380C9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93C7B6A-B727-48D8-B4BF-DD3516523B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0DCCB20-2C81-4548-9489-D6ABF73C42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822F6D8-56A9-4AAB-AB72-C973EE0DE9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8B1D34A-46E9-46BF-B15D-DC7197180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EB0AA08-BC26-4C5A-A0BB-E0364CB2C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8ECADFC-441F-44E6-BCAE-D62228938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613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4F4FDC-4FDD-49A0-9019-8DDDC5C5B8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19C8AA4-D757-46AC-9391-D2E6C920D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1AC09B83-ED53-4F74-92A8-2DD288F27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4FB9D74-4710-40CF-B662-7BF89A8A2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2487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4BA7927-AC89-4177-BF75-B4467EC88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9099D7F-787A-46A3-AFF9-E9A157487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9C29B55-0384-411F-ACD8-D7897932D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8262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C085C2C-2F4C-4C0F-8078-2BF26B530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5222ACA-2129-42DA-800B-49856B6B77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9B5A122-2F6E-4FEA-B2A8-67BDC6BC99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DD59E45-BFCC-4DCF-AE2A-801BF617A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7FFD5F9-5CC3-4ACC-979D-DC66C9653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251D2A7-3981-4CEB-A0B9-6D0481647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4690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86A673-5D85-4ED7-956A-6AF216A805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4114126-0FF2-4AD4-92D4-7D6B6C04D0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DA11408-A6A6-4ED6-95A5-124C374CD3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E1C002-B4C7-4CCC-A502-7B422E8F0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4F49D57-CD50-4769-A6D2-D9C47C76A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33B21F7-4AFD-47DD-ABB5-EA894C019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1799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0AB04BB-B608-439D-9E35-BD5176F9A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D63F36A-99C0-44D7-A78E-C887599CBF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84EF6F2-B2B0-4123-A813-7C294698C7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9EFED-F072-49B2-88B3-B1FDD1AD3D81}" type="datetimeFigureOut">
              <a:rPr lang="de-DE" smtClean="0"/>
              <a:t>15.07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38E2E20-4020-48C9-8673-8502657631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B644648-646E-483E-AC86-9E0594495C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A2ADD-FFAB-4D76-8ADD-B032B9EE280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3438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19438218-FB57-46D2-AD5A-452BAA8BD789}"/>
              </a:ext>
            </a:extLst>
          </p:cNvPr>
          <p:cNvSpPr/>
          <p:nvPr/>
        </p:nvSpPr>
        <p:spPr>
          <a:xfrm>
            <a:off x="351691" y="4799612"/>
            <a:ext cx="1137628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</a:rPr>
              <a:t>Supplementary Figure 1: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Drug interaction analysis of methylstat and olaparib according to the combination index (CI) method. Drugs were combined at a broad range of equipotent molar concentrations, according to the indicated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100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,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50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,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25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,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12.5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,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6.25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. Standard deviation from three independent experiments is indicated by error bars. Resulting CI-values and a ranking according to CI-values are indicated in the Table 1. Results were derived from three independent biological replicates.</a:t>
            </a:r>
            <a:endParaRPr lang="de-DE" sz="1200" dirty="0"/>
          </a:p>
        </p:txBody>
      </p:sp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2E842EF2-03B9-4AC5-BD7D-6E70BC1AEC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9478913"/>
              </p:ext>
            </p:extLst>
          </p:nvPr>
        </p:nvGraphicFramePr>
        <p:xfrm>
          <a:off x="4053200" y="851410"/>
          <a:ext cx="1997507" cy="18747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78" name="Prism 9" r:id="rId3" imgW="3829683" imgH="3592176" progId="Prism9.Document">
                  <p:embed/>
                </p:oleObj>
              </mc:Choice>
              <mc:Fallback>
                <p:oleObj name="Prism 9" r:id="rId3" imgW="3829683" imgH="3592176" progId="Prism9.Document">
                  <p:embed/>
                  <p:pic>
                    <p:nvPicPr>
                      <p:cNvPr id="41" name="Objekt 40">
                        <a:extLst>
                          <a:ext uri="{FF2B5EF4-FFF2-40B4-BE49-F238E27FC236}">
                            <a16:creationId xmlns:a16="http://schemas.microsoft.com/office/drawing/2014/main" id="{FA59CF2B-3C47-4C98-9E37-A5693CF716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53200" y="851410"/>
                        <a:ext cx="1997507" cy="18747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D4B05CA3-ABC9-45DD-A04E-2AA2EAE066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6523702"/>
              </p:ext>
            </p:extLst>
          </p:nvPr>
        </p:nvGraphicFramePr>
        <p:xfrm>
          <a:off x="8011635" y="888828"/>
          <a:ext cx="1911976" cy="1818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79" name="Prism 9" r:id="rId5" imgW="3832924" imgH="3640797" progId="Prism9.Document">
                  <p:embed/>
                </p:oleObj>
              </mc:Choice>
              <mc:Fallback>
                <p:oleObj name="Prism 9" r:id="rId5" imgW="3832924" imgH="3640797" progId="Prism9.Document">
                  <p:embed/>
                  <p:pic>
                    <p:nvPicPr>
                      <p:cNvPr id="42" name="Objekt 41">
                        <a:extLst>
                          <a:ext uri="{FF2B5EF4-FFF2-40B4-BE49-F238E27FC236}">
                            <a16:creationId xmlns:a16="http://schemas.microsoft.com/office/drawing/2014/main" id="{CA71EB9D-3303-4DB6-8E7C-DF8E81827C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11635" y="888828"/>
                        <a:ext cx="1911976" cy="1818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3BFFA35B-FAD7-4F68-B0D7-24E5FD81DD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1597805"/>
              </p:ext>
            </p:extLst>
          </p:nvPr>
        </p:nvGraphicFramePr>
        <p:xfrm>
          <a:off x="6047137" y="896552"/>
          <a:ext cx="1911976" cy="17662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0" name="Prism 9" r:id="rId7" imgW="3832924" imgH="3540314" progId="Prism9.Document">
                  <p:embed/>
                </p:oleObj>
              </mc:Choice>
              <mc:Fallback>
                <p:oleObj name="Prism 9" r:id="rId7" imgW="3832924" imgH="3540314" progId="Prism9.Document">
                  <p:embed/>
                  <p:pic>
                    <p:nvPicPr>
                      <p:cNvPr id="43" name="Objekt 42">
                        <a:extLst>
                          <a:ext uri="{FF2B5EF4-FFF2-40B4-BE49-F238E27FC236}">
                            <a16:creationId xmlns:a16="http://schemas.microsoft.com/office/drawing/2014/main" id="{6019AF8B-0942-4135-8BD4-9D0D809D08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47137" y="896552"/>
                        <a:ext cx="1911976" cy="17662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8E00AA8E-FE35-4458-887B-0D651315AC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7827675"/>
              </p:ext>
            </p:extLst>
          </p:nvPr>
        </p:nvGraphicFramePr>
        <p:xfrm>
          <a:off x="293512" y="876131"/>
          <a:ext cx="1911976" cy="18657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1" name="Prism 9" r:id="rId9" imgW="3822120" imgH="3729395" progId="Prism9.Document">
                  <p:embed/>
                </p:oleObj>
              </mc:Choice>
              <mc:Fallback>
                <p:oleObj name="Prism 9" r:id="rId9" imgW="3822120" imgH="3729395" progId="Prism9.Document">
                  <p:embed/>
                  <p:pic>
                    <p:nvPicPr>
                      <p:cNvPr id="44" name="Objekt 43">
                        <a:extLst>
                          <a:ext uri="{FF2B5EF4-FFF2-40B4-BE49-F238E27FC236}">
                            <a16:creationId xmlns:a16="http://schemas.microsoft.com/office/drawing/2014/main" id="{77437191-D6E2-42DF-9517-6D9DC2990E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3512" y="876131"/>
                        <a:ext cx="1911976" cy="18657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55B249B1-80BA-4145-A782-10C727D576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0016530"/>
              </p:ext>
            </p:extLst>
          </p:nvPr>
        </p:nvGraphicFramePr>
        <p:xfrm>
          <a:off x="9827043" y="2767473"/>
          <a:ext cx="1993937" cy="18936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2" name="Prism 9" r:id="rId11" imgW="3832924" imgH="3640797" progId="Prism9.Document">
                  <p:embed/>
                </p:oleObj>
              </mc:Choice>
              <mc:Fallback>
                <p:oleObj name="Prism 9" r:id="rId11" imgW="3832924" imgH="3640797" progId="Prism9.Document">
                  <p:embed/>
                  <p:pic>
                    <p:nvPicPr>
                      <p:cNvPr id="45" name="Objekt 44">
                        <a:extLst>
                          <a:ext uri="{FF2B5EF4-FFF2-40B4-BE49-F238E27FC236}">
                            <a16:creationId xmlns:a16="http://schemas.microsoft.com/office/drawing/2014/main" id="{B76143F7-43DB-4D59-B0DF-2BD4AAC2CD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827043" y="2767473"/>
                        <a:ext cx="1993937" cy="18936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E0E1E66A-F67A-49F9-A001-0C4218FA85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5282734"/>
              </p:ext>
            </p:extLst>
          </p:nvPr>
        </p:nvGraphicFramePr>
        <p:xfrm>
          <a:off x="2124577" y="2784948"/>
          <a:ext cx="1911976" cy="19392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3" name="Prism 9" r:id="rId13" imgW="3828243" imgH="3884982" progId="Prism9.Document">
                  <p:embed/>
                </p:oleObj>
              </mc:Choice>
              <mc:Fallback>
                <p:oleObj name="Prism 9" r:id="rId13" imgW="3828243" imgH="3884982" progId="Prism9.Document">
                  <p:embed/>
                  <p:pic>
                    <p:nvPicPr>
                      <p:cNvPr id="46" name="Objekt 45">
                        <a:extLst>
                          <a:ext uri="{FF2B5EF4-FFF2-40B4-BE49-F238E27FC236}">
                            <a16:creationId xmlns:a16="http://schemas.microsoft.com/office/drawing/2014/main" id="{48B6FE57-FFF4-4381-8A8A-047CCF920B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124577" y="2784948"/>
                        <a:ext cx="1911976" cy="19392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4419F4F1-70B5-4526-8B7F-97EBAE3BC2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732244"/>
              </p:ext>
            </p:extLst>
          </p:nvPr>
        </p:nvGraphicFramePr>
        <p:xfrm>
          <a:off x="2092272" y="872801"/>
          <a:ext cx="1993937" cy="1879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4" name="Prism 9" r:id="rId15" imgW="3832924" imgH="3613425" progId="Prism9.Document">
                  <p:embed/>
                </p:oleObj>
              </mc:Choice>
              <mc:Fallback>
                <p:oleObj name="Prism 9" r:id="rId15" imgW="3832924" imgH="3613425" progId="Prism9.Document">
                  <p:embed/>
                  <p:pic>
                    <p:nvPicPr>
                      <p:cNvPr id="47" name="Objekt 46">
                        <a:extLst>
                          <a:ext uri="{FF2B5EF4-FFF2-40B4-BE49-F238E27FC236}">
                            <a16:creationId xmlns:a16="http://schemas.microsoft.com/office/drawing/2014/main" id="{E0CC367F-7804-4CC6-BCE1-7208F0C5A3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92272" y="872801"/>
                        <a:ext cx="1993937" cy="1879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id="{7123B02C-29AC-447A-8CAE-253F4CEF24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2467299"/>
              </p:ext>
            </p:extLst>
          </p:nvPr>
        </p:nvGraphicFramePr>
        <p:xfrm>
          <a:off x="3884938" y="2817919"/>
          <a:ext cx="1997507" cy="18733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5" name="Prism 9" r:id="rId17" imgW="3832924" imgH="3595058" progId="Prism9.Document">
                  <p:embed/>
                </p:oleObj>
              </mc:Choice>
              <mc:Fallback>
                <p:oleObj name="Prism 9" r:id="rId17" imgW="3832924" imgH="3595058" progId="Prism9.Document">
                  <p:embed/>
                  <p:pic>
                    <p:nvPicPr>
                      <p:cNvPr id="49" name="Objekt 48">
                        <a:extLst>
                          <a:ext uri="{FF2B5EF4-FFF2-40B4-BE49-F238E27FC236}">
                            <a16:creationId xmlns:a16="http://schemas.microsoft.com/office/drawing/2014/main" id="{623029DA-1F32-4E64-A69F-E0C0916735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884938" y="2817919"/>
                        <a:ext cx="1997507" cy="18733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id="{59F4F5C2-F257-4578-9223-4B6FBBA4AF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5413170"/>
              </p:ext>
            </p:extLst>
          </p:nvPr>
        </p:nvGraphicFramePr>
        <p:xfrm>
          <a:off x="7833106" y="2795247"/>
          <a:ext cx="1993937" cy="1865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6" name="Prism 9" r:id="rId19" imgW="3832924" imgH="3586054" progId="Prism9.Document">
                  <p:embed/>
                </p:oleObj>
              </mc:Choice>
              <mc:Fallback>
                <p:oleObj name="Prism 9" r:id="rId19" imgW="3832924" imgH="3586054" progId="Prism9.Document">
                  <p:embed/>
                  <p:pic>
                    <p:nvPicPr>
                      <p:cNvPr id="50" name="Objekt 49">
                        <a:extLst>
                          <a:ext uri="{FF2B5EF4-FFF2-40B4-BE49-F238E27FC236}">
                            <a16:creationId xmlns:a16="http://schemas.microsoft.com/office/drawing/2014/main" id="{2089E2A8-082D-4FC6-80CB-4771F5F9E9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7833106" y="2795247"/>
                        <a:ext cx="1993937" cy="1865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id="{D8836C45-50BB-4EAD-AADC-FBDC9DC994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414183"/>
              </p:ext>
            </p:extLst>
          </p:nvPr>
        </p:nvGraphicFramePr>
        <p:xfrm>
          <a:off x="-540179" y="1986534"/>
          <a:ext cx="3390473" cy="2674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7" name="Prism 10" r:id="rId21" imgW="6390968" imgH="5046478" progId="Prism10.Document">
                  <p:embed/>
                </p:oleObj>
              </mc:Choice>
              <mc:Fallback>
                <p:oleObj name="Prism 10" r:id="rId21" imgW="6390968" imgH="5046478" progId="Prism10.Document">
                  <p:embed/>
                  <p:pic>
                    <p:nvPicPr>
                      <p:cNvPr id="51" name="Objekt 50">
                        <a:extLst>
                          <a:ext uri="{FF2B5EF4-FFF2-40B4-BE49-F238E27FC236}">
                            <a16:creationId xmlns:a16="http://schemas.microsoft.com/office/drawing/2014/main" id="{99A45D1C-9B39-42C1-8CA9-E766A75ACC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-540179" y="1986534"/>
                        <a:ext cx="3390473" cy="2674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id="{349028A2-3AB5-43C4-A774-313B9F2195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3288572"/>
              </p:ext>
            </p:extLst>
          </p:nvPr>
        </p:nvGraphicFramePr>
        <p:xfrm>
          <a:off x="5796914" y="2734957"/>
          <a:ext cx="2091090" cy="19608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8" name="Prism 9" r:id="rId23" imgW="3832924" imgH="3595058" progId="Prism9.Document">
                  <p:embed/>
                </p:oleObj>
              </mc:Choice>
              <mc:Fallback>
                <p:oleObj name="Prism 9" r:id="rId23" imgW="3832924" imgH="3595058" progId="Prism9.Document">
                  <p:embed/>
                  <p:pic>
                    <p:nvPicPr>
                      <p:cNvPr id="52" name="Objekt 51">
                        <a:extLst>
                          <a:ext uri="{FF2B5EF4-FFF2-40B4-BE49-F238E27FC236}">
                            <a16:creationId xmlns:a16="http://schemas.microsoft.com/office/drawing/2014/main" id="{DBE7BE6B-D4E0-48D7-B086-B93120C375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796914" y="2734957"/>
                        <a:ext cx="2091090" cy="19608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15206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FEA7E086-D8EA-43FA-B29D-D777C4862798}"/>
              </a:ext>
            </a:extLst>
          </p:cNvPr>
          <p:cNvSpPr/>
          <p:nvPr/>
        </p:nvSpPr>
        <p:spPr>
          <a:xfrm>
            <a:off x="1849763" y="5713483"/>
            <a:ext cx="77435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gure 2: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Drug interaction analysis of methylstat and olaparib according to HSA synergy scor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score &gt;10 indicates synergy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404E995F-81BF-49EB-A512-DCA7E49D6C48}"/>
              </a:ext>
            </a:extLst>
          </p:cNvPr>
          <p:cNvGrpSpPr/>
          <p:nvPr/>
        </p:nvGrpSpPr>
        <p:grpSpPr>
          <a:xfrm>
            <a:off x="3243730" y="306185"/>
            <a:ext cx="4955656" cy="5322299"/>
            <a:chOff x="3220284" y="281332"/>
            <a:chExt cx="4955656" cy="5322299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A9AAA675-F75F-4CCA-AD92-B1112E3190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1462" t="36664" r="26415" b="25323"/>
            <a:stretch/>
          </p:blipFill>
          <p:spPr>
            <a:xfrm>
              <a:off x="3220284" y="281332"/>
              <a:ext cx="4955656" cy="5322299"/>
            </a:xfrm>
            <a:prstGeom prst="rect">
              <a:avLst/>
            </a:prstGeom>
          </p:spPr>
        </p:pic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E3102DA5-63F5-459D-AC34-528F61506310}"/>
                </a:ext>
              </a:extLst>
            </p:cNvPr>
            <p:cNvSpPr txBox="1"/>
            <p:nvPr/>
          </p:nvSpPr>
          <p:spPr>
            <a:xfrm rot="3176394">
              <a:off x="3553107" y="4721941"/>
              <a:ext cx="127331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400" b="1" dirty="0" err="1"/>
                <a:t>Olaparib</a:t>
              </a:r>
              <a:r>
                <a:rPr lang="de-DE" sz="1400" b="1" dirty="0"/>
                <a:t> (µM)</a:t>
              </a:r>
            </a:p>
          </p:txBody>
        </p:sp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3A30BD83-3A7C-4DE1-9270-BA9F7BDDC038}"/>
                </a:ext>
              </a:extLst>
            </p:cNvPr>
            <p:cNvSpPr txBox="1"/>
            <p:nvPr/>
          </p:nvSpPr>
          <p:spPr>
            <a:xfrm rot="20240276">
              <a:off x="5884806" y="4965086"/>
              <a:ext cx="146266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400" b="1" dirty="0" err="1"/>
                <a:t>Methylstat</a:t>
              </a:r>
              <a:r>
                <a:rPr lang="de-DE" sz="1400" b="1" dirty="0"/>
                <a:t> (µM)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175AC7B6-D8B8-45D7-8FE9-8B726E5C2BB3}"/>
                </a:ext>
              </a:extLst>
            </p:cNvPr>
            <p:cNvSpPr txBox="1"/>
            <p:nvPr/>
          </p:nvSpPr>
          <p:spPr>
            <a:xfrm rot="16200000">
              <a:off x="2714010" y="2788592"/>
              <a:ext cx="146266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400" b="1" dirty="0"/>
                <a:t>Synergy score</a:t>
              </a:r>
            </a:p>
          </p:txBody>
        </p:sp>
      </p:grpSp>
      <p:sp>
        <p:nvSpPr>
          <p:cNvPr id="8" name="Rechteck 7">
            <a:extLst>
              <a:ext uri="{FF2B5EF4-FFF2-40B4-BE49-F238E27FC236}">
                <a16:creationId xmlns:a16="http://schemas.microsoft.com/office/drawing/2014/main" id="{ABF73387-D41B-4194-80BA-9D1903C8917A}"/>
              </a:ext>
            </a:extLst>
          </p:cNvPr>
          <p:cNvSpPr/>
          <p:nvPr/>
        </p:nvSpPr>
        <p:spPr>
          <a:xfrm>
            <a:off x="3048000" y="2967335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839407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FF7D3DC4-D2A2-49BC-8FA5-9FC0CFB820E4}"/>
              </a:ext>
            </a:extLst>
          </p:cNvPr>
          <p:cNvSpPr txBox="1"/>
          <p:nvPr/>
        </p:nvSpPr>
        <p:spPr>
          <a:xfrm>
            <a:off x="163518" y="31174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78ACF6E-48F6-457C-988E-658C97DAF954}"/>
              </a:ext>
            </a:extLst>
          </p:cNvPr>
          <p:cNvSpPr txBox="1"/>
          <p:nvPr/>
        </p:nvSpPr>
        <p:spPr>
          <a:xfrm>
            <a:off x="3919902" y="311742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B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73DFB031-39B0-4F0D-9331-6DB4A7427207}"/>
              </a:ext>
            </a:extLst>
          </p:cNvPr>
          <p:cNvSpPr txBox="1"/>
          <p:nvPr/>
        </p:nvSpPr>
        <p:spPr>
          <a:xfrm>
            <a:off x="8128661" y="311742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C</a:t>
            </a:r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FFBBE12B-AC65-4684-A1AA-7C1CF3C750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3869057"/>
              </p:ext>
            </p:extLst>
          </p:nvPr>
        </p:nvGraphicFramePr>
        <p:xfrm>
          <a:off x="1193235" y="3731150"/>
          <a:ext cx="2174614" cy="737749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376993">
                  <a:extLst>
                    <a:ext uri="{9D8B030D-6E8A-4147-A177-3AD203B41FA5}">
                      <a16:colId xmlns:a16="http://schemas.microsoft.com/office/drawing/2014/main" val="3199485002"/>
                    </a:ext>
                  </a:extLst>
                </a:gridCol>
                <a:gridCol w="797621">
                  <a:extLst>
                    <a:ext uri="{9D8B030D-6E8A-4147-A177-3AD203B41FA5}">
                      <a16:colId xmlns:a16="http://schemas.microsoft.com/office/drawing/2014/main" val="3304854689"/>
                    </a:ext>
                  </a:extLst>
                </a:gridCol>
              </a:tblGrid>
              <a:tr h="250069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 err="1"/>
                        <a:t>Cell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line</a:t>
                      </a:r>
                      <a:endParaRPr lang="de-DE" sz="1000" dirty="0"/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IC</a:t>
                      </a:r>
                      <a:r>
                        <a:rPr lang="de-DE" sz="1000" baseline="-25000" dirty="0"/>
                        <a:t>50</a:t>
                      </a:r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565679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Igrov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1.9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785578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Olres-Igrov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22.0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4081849"/>
                  </a:ext>
                </a:extLst>
              </a:tr>
            </a:tbl>
          </a:graphicData>
        </a:graphic>
      </p:graphicFrame>
      <p:graphicFrame>
        <p:nvGraphicFramePr>
          <p:cNvPr id="34" name="Tabelle 33">
            <a:extLst>
              <a:ext uri="{FF2B5EF4-FFF2-40B4-BE49-F238E27FC236}">
                <a16:creationId xmlns:a16="http://schemas.microsoft.com/office/drawing/2014/main" id="{543B68AC-196C-4666-9AD2-CCF9A21D04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5190373"/>
              </p:ext>
            </p:extLst>
          </p:nvPr>
        </p:nvGraphicFramePr>
        <p:xfrm>
          <a:off x="5050280" y="3731150"/>
          <a:ext cx="2174614" cy="737749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373736">
                  <a:extLst>
                    <a:ext uri="{9D8B030D-6E8A-4147-A177-3AD203B41FA5}">
                      <a16:colId xmlns:a16="http://schemas.microsoft.com/office/drawing/2014/main" val="3199485002"/>
                    </a:ext>
                  </a:extLst>
                </a:gridCol>
                <a:gridCol w="800878">
                  <a:extLst>
                    <a:ext uri="{9D8B030D-6E8A-4147-A177-3AD203B41FA5}">
                      <a16:colId xmlns:a16="http://schemas.microsoft.com/office/drawing/2014/main" val="3304854689"/>
                    </a:ext>
                  </a:extLst>
                </a:gridCol>
              </a:tblGrid>
              <a:tr h="250069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 err="1"/>
                        <a:t>Cell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line</a:t>
                      </a:r>
                      <a:endParaRPr lang="de-DE" sz="1000" dirty="0"/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IC</a:t>
                      </a:r>
                      <a:r>
                        <a:rPr lang="de-DE" sz="1000" baseline="-25000" dirty="0"/>
                        <a:t>50</a:t>
                      </a:r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5656792"/>
                  </a:ext>
                </a:extLst>
              </a:tr>
              <a:tr h="150041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KB1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0.0083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785578"/>
                  </a:ext>
                </a:extLst>
              </a:tr>
              <a:tr h="150041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Olres-KB1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1.2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4081849"/>
                  </a:ext>
                </a:extLst>
              </a:tr>
            </a:tbl>
          </a:graphicData>
        </a:graphic>
      </p:graphicFrame>
      <p:graphicFrame>
        <p:nvGraphicFramePr>
          <p:cNvPr id="35" name="Tabelle 34">
            <a:extLst>
              <a:ext uri="{FF2B5EF4-FFF2-40B4-BE49-F238E27FC236}">
                <a16:creationId xmlns:a16="http://schemas.microsoft.com/office/drawing/2014/main" id="{F8E1799D-8752-444D-82C8-664420A1BD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6009967"/>
              </p:ext>
            </p:extLst>
          </p:nvPr>
        </p:nvGraphicFramePr>
        <p:xfrm>
          <a:off x="9241281" y="3731151"/>
          <a:ext cx="2174614" cy="73152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323374">
                  <a:extLst>
                    <a:ext uri="{9D8B030D-6E8A-4147-A177-3AD203B41FA5}">
                      <a16:colId xmlns:a16="http://schemas.microsoft.com/office/drawing/2014/main" val="3199485002"/>
                    </a:ext>
                  </a:extLst>
                </a:gridCol>
                <a:gridCol w="851240">
                  <a:extLst>
                    <a:ext uri="{9D8B030D-6E8A-4147-A177-3AD203B41FA5}">
                      <a16:colId xmlns:a16="http://schemas.microsoft.com/office/drawing/2014/main" val="3304854689"/>
                    </a:ext>
                  </a:extLst>
                </a:gridCol>
              </a:tblGrid>
              <a:tr h="222861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 err="1"/>
                        <a:t>Cell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line</a:t>
                      </a:r>
                      <a:endParaRPr lang="de-DE" sz="1000" dirty="0"/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IC</a:t>
                      </a:r>
                      <a:r>
                        <a:rPr lang="de-DE" sz="1000" baseline="-25000" dirty="0"/>
                        <a:t>50</a:t>
                      </a:r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5656792"/>
                  </a:ext>
                </a:extLst>
              </a:tr>
              <a:tr h="222861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KB1P+BRC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0.36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785578"/>
                  </a:ext>
                </a:extLst>
              </a:tr>
              <a:tr h="236102"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Olres-KB1P+BRC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72.11 µM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4081849"/>
                  </a:ext>
                </a:extLst>
              </a:tr>
            </a:tbl>
          </a:graphicData>
        </a:graphic>
      </p:graphicFrame>
      <p:sp>
        <p:nvSpPr>
          <p:cNvPr id="10" name="Rechteck 9">
            <a:extLst>
              <a:ext uri="{FF2B5EF4-FFF2-40B4-BE49-F238E27FC236}">
                <a16:creationId xmlns:a16="http://schemas.microsoft.com/office/drawing/2014/main" id="{F8693C2D-D59A-4580-AD32-1D45011E1B2C}"/>
              </a:ext>
            </a:extLst>
          </p:cNvPr>
          <p:cNvSpPr/>
          <p:nvPr/>
        </p:nvSpPr>
        <p:spPr>
          <a:xfrm>
            <a:off x="163518" y="4736123"/>
            <a:ext cx="1163771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</a:rPr>
              <a:t>Supplementary Figure 3: Basic characterization of in vitro models for PARPi-resistance.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The figure shows olaparib dose-response curves according to 6-day photometric viability assays of (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) Igrov-1 human ovarian cancer cells (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) </a:t>
            </a:r>
            <a:r>
              <a:rPr lang="en-US" sz="1200" i="1" dirty="0">
                <a:latin typeface="Arial" panose="020B0604020202020204" pitchFamily="34" charset="0"/>
                <a:ea typeface="MS Mincho" panose="02020609040205080304" pitchFamily="49" charset="-128"/>
              </a:rPr>
              <a:t>BRCA1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-deficient KB1P murine breast cancer (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) BRCA1-proficient KB1P murine breast cancer cells in comparison to their respective isogenic derivative cell lines with experimentally acquired PARPi-resistance. PARPi resistance was acquired by chronic exposure to incrementally ascending concentrations of olaparib. IC</a:t>
            </a:r>
            <a:r>
              <a:rPr lang="en-US" sz="1200" baseline="-25000" dirty="0">
                <a:latin typeface="Arial" panose="020B0604020202020204" pitchFamily="34" charset="0"/>
                <a:ea typeface="MS Mincho" panose="02020609040205080304" pitchFamily="49" charset="-128"/>
              </a:rPr>
              <a:t>50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 values are indicated according to non-linear regression analysis of normalized drug response; p-value levels were calculated according to nested t-test of dose-response curves; **p &lt; 0.01, **** p &lt; 0.0001. Results were derived from three independent biological replicates.</a:t>
            </a:r>
            <a:endParaRPr lang="de-DE" sz="1200" dirty="0"/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54E89792-6AC8-40A1-920F-45C6F38904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4806521"/>
              </p:ext>
            </p:extLst>
          </p:nvPr>
        </p:nvGraphicFramePr>
        <p:xfrm>
          <a:off x="328613" y="858838"/>
          <a:ext cx="3757612" cy="2627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0" name="Prism 10" r:id="rId3" imgW="3860743" imgH="2697433" progId="Prism10.Document">
                  <p:embed/>
                </p:oleObj>
              </mc:Choice>
              <mc:Fallback>
                <p:oleObj name="Prism 10" r:id="rId3" imgW="3860743" imgH="26974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8613" y="858838"/>
                        <a:ext cx="3757612" cy="2627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DB418087-5922-49BF-A885-0C17BFC63B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0141305"/>
              </p:ext>
            </p:extLst>
          </p:nvPr>
        </p:nvGraphicFramePr>
        <p:xfrm>
          <a:off x="4215606" y="839789"/>
          <a:ext cx="3760787" cy="262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1" name="Prism 10" r:id="rId5" imgW="3860743" imgH="2697433" progId="Prism10.Document">
                  <p:embed/>
                </p:oleObj>
              </mc:Choice>
              <mc:Fallback>
                <p:oleObj name="Prism 10" r:id="rId5" imgW="3860743" imgH="26974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15606" y="839789"/>
                        <a:ext cx="3760787" cy="262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139A3CE6-AD85-4975-AC73-977BD8317B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7717016"/>
              </p:ext>
            </p:extLst>
          </p:nvPr>
        </p:nvGraphicFramePr>
        <p:xfrm>
          <a:off x="8283575" y="858838"/>
          <a:ext cx="3760788" cy="262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2" name="Prism 10" r:id="rId7" imgW="3860743" imgH="2697433" progId="Prism10.Document">
                  <p:embed/>
                </p:oleObj>
              </mc:Choice>
              <mc:Fallback>
                <p:oleObj name="Prism 10" r:id="rId7" imgW="3860743" imgH="26974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283575" y="858838"/>
                        <a:ext cx="3760788" cy="262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18209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6</Words>
  <Application>Microsoft Office PowerPoint</Application>
  <PresentationFormat>Breitbild</PresentationFormat>
  <Paragraphs>28</Paragraphs>
  <Slides>3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3</vt:i4>
      </vt:variant>
    </vt:vector>
  </HeadingPairs>
  <TitlesOfParts>
    <vt:vector size="10" baseType="lpstr">
      <vt:lpstr>MS Mincho</vt:lpstr>
      <vt:lpstr>Arial</vt:lpstr>
      <vt:lpstr>Calibri</vt:lpstr>
      <vt:lpstr>Calibri Light</vt:lpstr>
      <vt:lpstr>Office</vt:lpstr>
      <vt:lpstr>Prism 9</vt:lpstr>
      <vt:lpstr>Prism 10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uhlmann, Jan</dc:creator>
  <cp:lastModifiedBy>Schwarz, Franziska</cp:lastModifiedBy>
  <cp:revision>38</cp:revision>
  <dcterms:created xsi:type="dcterms:W3CDTF">2024-05-23T12:08:48Z</dcterms:created>
  <dcterms:modified xsi:type="dcterms:W3CDTF">2024-07-15T12:26:24Z</dcterms:modified>
</cp:coreProperties>
</file>